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77724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572" y="-12"/>
      </p:cViewPr>
      <p:guideLst>
        <p:guide orient="horz" pos="244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414482"/>
            <a:ext cx="7772400" cy="1666028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4404360"/>
            <a:ext cx="640080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1403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7224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311257"/>
            <a:ext cx="2057400" cy="66317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311257"/>
            <a:ext cx="6019800" cy="66317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9926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4828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994487"/>
            <a:ext cx="777240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3294275"/>
            <a:ext cx="777240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5681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813560"/>
            <a:ext cx="4038600" cy="51294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813560"/>
            <a:ext cx="4038600" cy="51294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4757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739795"/>
            <a:ext cx="4040188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464859"/>
            <a:ext cx="4040188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6" y="1739795"/>
            <a:ext cx="4041775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6" y="2464859"/>
            <a:ext cx="4041775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6594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7053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9160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1" y="309457"/>
            <a:ext cx="3008313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309457"/>
            <a:ext cx="5111750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1" y="1626447"/>
            <a:ext cx="3008313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6231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5440680"/>
            <a:ext cx="548640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94478"/>
            <a:ext cx="548640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6082983"/>
            <a:ext cx="548640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8248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311256"/>
            <a:ext cx="822960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813560"/>
            <a:ext cx="822960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7203864"/>
            <a:ext cx="213360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766E0-EBBB-40FD-B558-5413F7DF9BF3}" type="datetimeFigureOut">
              <a:rPr lang="es-ES" smtClean="0"/>
              <a:t>06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7203864"/>
            <a:ext cx="289560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7203864"/>
            <a:ext cx="213360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B3714-86F6-48E4-855D-1E42D3CEDAE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886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228600" y="6934200"/>
            <a:ext cx="8763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3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Bar plot showing additional quality traits mean values according to the corresponding haplotype.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Means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with a different letter on the top indicate significant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differences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according </a:t>
            </a:r>
            <a:r>
              <a:rPr lang="en-US" sz="1400" dirty="0" err="1">
                <a:latin typeface="Arial" pitchFamily="34" charset="0"/>
                <a:cs typeface="Arial" pitchFamily="34" charset="0"/>
              </a:rPr>
              <a:t>Tukey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-Kramer test (p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&lt;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0.05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)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Picture 2" descr="C:\Users\Pablo\Documents\LABORAL\INVESTIGACION\PUBLICACIONES\Publicaciones en curso\2019 GLU loci\ANALISIS\INFOSTAT\ANOVA\2021\Haplo vs Reologicals\TABLA HAPLO\DT vs haplo sin outliers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5969" y="381000"/>
            <a:ext cx="4295631" cy="32337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3" descr="C:\Users\Pablo\Documents\LABORAL\INVESTIGACION\PUBLICACIONES\Publicaciones en curso\2019 GLU loci\ANALISIS\INFOSTAT\ANOVA\2021\Haplo vs Reologicals\TABLA HAPLO\EL vs haplo sin outliers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994" y="3595110"/>
            <a:ext cx="4295631" cy="32337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" descr="C:\Users\Pablo\Documents\LABORAL\INVESTIGACION\PUBLICACIONES\Publicaciones en curso\2019 GLU loci\ANALISIS\INFOSTAT\ANOVA\2021\Haplo vs Reologicals\TABLA HAPLO\GI vs haplo sin outliers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969" y="394710"/>
            <a:ext cx="4295631" cy="32337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5" descr="C:\Users\Pablo\Documents\LABORAL\INVESTIGACION\PUBLICACIONES\Publicaciones en curso\2019 GLU loci\ANALISIS\INFOSTAT\ANOVA\2021\Haplo vs Reologicals\TABLA HAPLO\GPC vs haplo sin outliers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2012" y="3595592"/>
            <a:ext cx="4295631" cy="32337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920974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6</TotalTime>
  <Words>35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7</cp:revision>
  <dcterms:created xsi:type="dcterms:W3CDTF">2021-09-05T15:38:10Z</dcterms:created>
  <dcterms:modified xsi:type="dcterms:W3CDTF">2021-11-07T13:45:41Z</dcterms:modified>
</cp:coreProperties>
</file>